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18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DCC </a:t>
            </a:r>
            <a:r>
              <a:rPr lang="en-GB" sz="1600" dirty="0" smtClean="0"/>
              <a:t>gene. A) Wild (Template</a:t>
            </a:r>
            <a:r>
              <a:rPr lang="en-US" sz="1600" dirty="0" smtClean="0"/>
              <a:t> 3laf_A)</a:t>
            </a:r>
            <a:r>
              <a:rPr lang="en-GB" sz="1600" dirty="0" smtClean="0"/>
              <a:t>, B) Mutant (Template</a:t>
            </a:r>
            <a:r>
              <a:rPr lang="en-US" sz="1600" dirty="0" smtClean="0"/>
              <a:t> 3laf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85721" y="285728"/>
            <a:ext cx="3449116" cy="27146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357818" y="142852"/>
            <a:ext cx="2714644" cy="2996294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85721" y="3244793"/>
            <a:ext cx="3429023" cy="25416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357818" y="3190068"/>
            <a:ext cx="2714644" cy="2750949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62</cp:revision>
  <dcterms:created xsi:type="dcterms:W3CDTF">2018-05-10T07:33:24Z</dcterms:created>
  <dcterms:modified xsi:type="dcterms:W3CDTF">2018-05-29T06:59:25Z</dcterms:modified>
</cp:coreProperties>
</file>